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646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C75CBB-1157-40F9-AFF8-8E83DF54C446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8D1B7-231B-4C77-9CA4-7C508C34A989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43467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CA" dirty="0" smtClean="0"/>
              <a:t>Supplementary </a:t>
            </a:r>
            <a:r>
              <a:rPr lang="en-CA" smtClean="0"/>
              <a:t>Figure </a:t>
            </a:r>
            <a:r>
              <a:rPr lang="en-CA" smtClean="0"/>
              <a:t>2</a:t>
            </a:r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2CC88B7-DE8F-450E-A02D-FEED2AE35043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22499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471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84212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331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34356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154426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7325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2547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59341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16703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00868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4117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FBF176-4DF5-4D48-A41A-288A8F686CA7}" type="datetimeFigureOut">
              <a:rPr lang="en-CA" smtClean="0"/>
              <a:t>29/07/20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4A0031-ACE0-40BE-B0FC-59A28F6E897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7116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498950" y="345014"/>
            <a:ext cx="441851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 Narrow" panose="020B0606020202030204" pitchFamily="34" charset="0"/>
              </a:rPr>
              <a:t>Training: 95-Gene Risk Model with no Clinical Covariates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51020" y="617833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491874" y="643498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B</a:t>
            </a:r>
            <a:endParaRPr lang="en-CA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94205" y="3277732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C</a:t>
            </a:r>
            <a:endParaRPr lang="en-CA" sz="20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435059" y="3294842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 smtClean="0"/>
              <a:t>D</a:t>
            </a:r>
            <a:endParaRPr lang="en-CA" sz="20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1675542" y="3083301"/>
            <a:ext cx="39857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 Narrow" panose="020B0606020202030204" pitchFamily="34" charset="0"/>
              </a:rPr>
              <a:t>Training: 95-Gene Risk Model + Clinical Covariates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pic>
        <p:nvPicPr>
          <p:cNvPr id="5124" name="Picture 4" descr="T:\Transfer\Cindy\Old-Folders\For-Jane\PROTECT2\Training\No-Chemo\Training KMs and quartiles\2015-06-05_TEAM-IOT_KM-TEAM-TrainingcrossValidation_DRFS_SIMMS-Only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445" y="619355"/>
            <a:ext cx="2296088" cy="2296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T:\Transfer\Cindy\Old-Folders\For-Jane\PROTECT2\Training\No-Chemo\Training KMs and quartiles\2015-06-05_TEAM-IOT_KM-TEAM-TrainingcrossValidation_DRFS_SIMMS-Only_Quartiles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7226" y="619355"/>
            <a:ext cx="2624102" cy="2296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6" name="Picture 6" descr="T:\Transfer\Cindy\Old-Folders\For-Jane\PROTECT2\Training\No-Chemo\Training KMs and quartiles\2015-06-05_TEAM-IOT_KM-TEAM-TrainingcrossValidation_DRFS_SIMMS-Clinical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580" y="3369641"/>
            <a:ext cx="2348591" cy="23485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7" name="Picture 7" descr="T:\Transfer\Cindy\Old-Folders\For-Jane\PROTECT2\Training\No-Chemo\Training KMs and quartiles\2015-06-05_TEAM-IOT_KM-TEAM-TrainingcrossValidation_DRFS_SIMMS-Clinical_Quartiles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3365561"/>
            <a:ext cx="2695506" cy="23585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439164" y="6243012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501008" y="6260122"/>
            <a:ext cx="3016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b="1" dirty="0"/>
              <a:t>F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698619" y="5961638"/>
            <a:ext cx="36025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600" dirty="0" smtClean="0">
                <a:latin typeface="Arial Narrow" panose="020B0606020202030204" pitchFamily="34" charset="0"/>
              </a:rPr>
              <a:t>Training: 95-Gene Risk Model + Nodal Status</a:t>
            </a:r>
            <a:endParaRPr lang="en-CA" sz="1600" dirty="0">
              <a:latin typeface="Arial Narrow" panose="020B0606020202030204" pitchFamily="34" charset="0"/>
            </a:endParaRPr>
          </a:p>
        </p:txBody>
      </p:sp>
      <p:pic>
        <p:nvPicPr>
          <p:cNvPr id="18" name="Picture 5" descr="T:\Transfer\Cindy\Old-Folders\For-Jane\PROTECT2\Training\No-Chemo\Training KMs and quartiles\2015-06-05_TEAM-IOT_KM-TEAM-TrainingcrossValidation_DRFS_SIMMS-Clinical-Refined_Quartiles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8268" y="6301680"/>
            <a:ext cx="2839687" cy="248472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4" descr="T:\Transfer\Cindy\Old-Folders\For-Jane\PROTECT2\Training\No-Chemo\Training KMs and quartiles\2015-06-05_TEAM-IOT_KM-TEAM-TrainingcrossValidation_DRFS_SIMMS-Clinical-Refined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3122" y="6250998"/>
            <a:ext cx="2493852" cy="24938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119464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5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Jane Bayani</cp:lastModifiedBy>
  <cp:revision>9</cp:revision>
  <dcterms:created xsi:type="dcterms:W3CDTF">2016-05-05T14:49:32Z</dcterms:created>
  <dcterms:modified xsi:type="dcterms:W3CDTF">2016-07-29T18:36:49Z</dcterms:modified>
</cp:coreProperties>
</file>